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822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DAA9E"/>
    <a:srgbClr val="F5B7BF"/>
    <a:srgbClr val="ED8390"/>
    <a:srgbClr val="7DDFD6"/>
    <a:srgbClr val="D4F4F1"/>
    <a:srgbClr val="FFCC99"/>
    <a:srgbClr val="FF9933"/>
    <a:srgbClr val="E3F2D9"/>
    <a:srgbClr val="ACD78E"/>
    <a:srgbClr val="D0E7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43" autoAdjust="0"/>
    <p:restoredTop sz="66620" autoAdjust="0"/>
  </p:normalViewPr>
  <p:slideViewPr>
    <p:cSldViewPr snapToGrid="0">
      <p:cViewPr>
        <p:scale>
          <a:sx n="50" d="100"/>
          <a:sy n="50" d="100"/>
        </p:scale>
        <p:origin x="1284" y="-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E6F573-7E06-4AF2-81A0-DD0AFEBFBBF9}" type="datetimeFigureOut">
              <a:rPr lang="zh-CN" altLang="en-US" smtClean="0"/>
              <a:t>2026/1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E87246-070C-4DD1-B41D-1B06226838C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48366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E87246-070C-4DD1-B41D-1B06226838C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4598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1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4070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55" r:id="rId1"/>
    <p:sldLayoutId id="2147483662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6CD1ACE-699B-E892-E85F-D90D4D3182B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组合 47">
            <a:extLst>
              <a:ext uri="{FF2B5EF4-FFF2-40B4-BE49-F238E27FC236}">
                <a16:creationId xmlns:a16="http://schemas.microsoft.com/office/drawing/2014/main" id="{38C790E2-B1DE-E589-ECC8-12294C59B384}"/>
              </a:ext>
            </a:extLst>
          </p:cNvPr>
          <p:cNvGrpSpPr/>
          <p:nvPr/>
        </p:nvGrpSpPr>
        <p:grpSpPr>
          <a:xfrm>
            <a:off x="-195942" y="837794"/>
            <a:ext cx="12192000" cy="5628322"/>
            <a:chOff x="-4916384" y="-2612794"/>
            <a:chExt cx="23139396" cy="10682085"/>
          </a:xfrm>
        </p:grpSpPr>
        <p:grpSp>
          <p:nvGrpSpPr>
            <p:cNvPr id="37" name="组合 36">
              <a:extLst>
                <a:ext uri="{FF2B5EF4-FFF2-40B4-BE49-F238E27FC236}">
                  <a16:creationId xmlns:a16="http://schemas.microsoft.com/office/drawing/2014/main" id="{5E1E6943-BA56-C47E-E7E0-0DBBCC83CE7C}"/>
                </a:ext>
              </a:extLst>
            </p:cNvPr>
            <p:cNvGrpSpPr/>
            <p:nvPr/>
          </p:nvGrpSpPr>
          <p:grpSpPr>
            <a:xfrm>
              <a:off x="3157450" y="-2612794"/>
              <a:ext cx="7468751" cy="5276387"/>
              <a:chOff x="-1144151" y="-3495409"/>
              <a:chExt cx="7468751" cy="5276387"/>
            </a:xfrm>
          </p:grpSpPr>
          <p:pic>
            <p:nvPicPr>
              <p:cNvPr id="18" name="图片 17">
                <a:extLst>
                  <a:ext uri="{FF2B5EF4-FFF2-40B4-BE49-F238E27FC236}">
                    <a16:creationId xmlns:a16="http://schemas.microsoft.com/office/drawing/2014/main" id="{1ED2A734-7650-56B3-D8B4-AD7CF1EE4F7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3022" r="871"/>
              <a:stretch>
                <a:fillRect/>
              </a:stretch>
            </p:blipFill>
            <p:spPr>
              <a:xfrm>
                <a:off x="-1144151" y="-3495409"/>
                <a:ext cx="7468751" cy="5276387"/>
              </a:xfrm>
              <a:prstGeom prst="rect">
                <a:avLst/>
              </a:prstGeom>
            </p:spPr>
          </p:pic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A236C25D-DF13-2AB1-07CF-989C346C8C43}"/>
                  </a:ext>
                </a:extLst>
              </p:cNvPr>
              <p:cNvSpPr txBox="1"/>
              <p:nvPr/>
            </p:nvSpPr>
            <p:spPr>
              <a:xfrm>
                <a:off x="-1131710" y="-3448343"/>
                <a:ext cx="642027" cy="49651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04448A1C-D713-E946-BBE8-C58F8734C787}"/>
                  </a:ext>
                </a:extLst>
              </p:cNvPr>
              <p:cNvSpPr txBox="1"/>
              <p:nvPr/>
            </p:nvSpPr>
            <p:spPr>
              <a:xfrm>
                <a:off x="1617762" y="-498335"/>
                <a:ext cx="2319239" cy="43810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9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one TR</a:t>
                </a:r>
                <a:endParaRPr lang="zh-CN" altLang="en-US" sz="9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id="{9D48073F-504B-8FDD-0DD0-D312E0C47E5E}"/>
                </a:ext>
              </a:extLst>
            </p:cNvPr>
            <p:cNvGrpSpPr/>
            <p:nvPr/>
          </p:nvGrpSpPr>
          <p:grpSpPr>
            <a:xfrm>
              <a:off x="3157450" y="2792904"/>
              <a:ext cx="7468751" cy="5276387"/>
              <a:chOff x="3066900" y="2792904"/>
              <a:chExt cx="7468751" cy="5276387"/>
            </a:xfrm>
          </p:grpSpPr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22AB749D-207B-8178-4E01-8FC5B68E66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rcRect l="5390" t="3288" b="1069"/>
              <a:stretch>
                <a:fillRect/>
              </a:stretch>
            </p:blipFill>
            <p:spPr>
              <a:xfrm>
                <a:off x="3066900" y="2792904"/>
                <a:ext cx="7468751" cy="5276387"/>
              </a:xfrm>
              <a:prstGeom prst="rect">
                <a:avLst/>
              </a:prstGeom>
            </p:spPr>
          </p:pic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71297868-38D1-9979-B0AE-C2EFC192BE4C}"/>
                  </a:ext>
                </a:extLst>
              </p:cNvPr>
              <p:cNvSpPr txBox="1"/>
              <p:nvPr/>
            </p:nvSpPr>
            <p:spPr>
              <a:xfrm>
                <a:off x="3079236" y="2802692"/>
                <a:ext cx="642027" cy="49651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1655601A-597A-F387-890E-4398F22395E2}"/>
                </a:ext>
              </a:extLst>
            </p:cNvPr>
            <p:cNvSpPr txBox="1"/>
            <p:nvPr/>
          </p:nvSpPr>
          <p:spPr>
            <a:xfrm>
              <a:off x="5704492" y="5598134"/>
              <a:ext cx="2167726" cy="46730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rivial MR</a:t>
              </a:r>
              <a:endParaRPr lang="zh-CN" alt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1" name="组合 40">
              <a:extLst>
                <a:ext uri="{FF2B5EF4-FFF2-40B4-BE49-F238E27FC236}">
                  <a16:creationId xmlns:a16="http://schemas.microsoft.com/office/drawing/2014/main" id="{0610045B-DAEE-D6C8-E0A7-DA8038CE2A6C}"/>
                </a:ext>
              </a:extLst>
            </p:cNvPr>
            <p:cNvGrpSpPr/>
            <p:nvPr/>
          </p:nvGrpSpPr>
          <p:grpSpPr>
            <a:xfrm>
              <a:off x="-4916384" y="-2612794"/>
              <a:ext cx="7945775" cy="5276387"/>
              <a:chOff x="-9191840" y="-3495409"/>
              <a:chExt cx="7945775" cy="5276387"/>
            </a:xfrm>
          </p:grpSpPr>
          <p:pic>
            <p:nvPicPr>
              <p:cNvPr id="17" name="图片 16">
                <a:extLst>
                  <a:ext uri="{FF2B5EF4-FFF2-40B4-BE49-F238E27FC236}">
                    <a16:creationId xmlns:a16="http://schemas.microsoft.com/office/drawing/2014/main" id="{1E5946EB-A7AC-CB71-C6BE-826822BC59B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rcRect r="259"/>
              <a:stretch>
                <a:fillRect/>
              </a:stretch>
            </p:blipFill>
            <p:spPr>
              <a:xfrm>
                <a:off x="-8714816" y="-3495409"/>
                <a:ext cx="7468751" cy="5276387"/>
              </a:xfrm>
              <a:prstGeom prst="rect">
                <a:avLst/>
              </a:prstGeom>
            </p:spPr>
          </p:pic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3B54227C-03BA-4444-53DF-9D160F29ACF5}"/>
                  </a:ext>
                </a:extLst>
              </p:cNvPr>
              <p:cNvSpPr txBox="1"/>
              <p:nvPr/>
            </p:nvSpPr>
            <p:spPr>
              <a:xfrm>
                <a:off x="-8662308" y="-3448343"/>
                <a:ext cx="642027" cy="49651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AC16959A-014E-28A7-4CD7-588C35BCB193}"/>
                  </a:ext>
                </a:extLst>
              </p:cNvPr>
              <p:cNvSpPr txBox="1"/>
              <p:nvPr/>
            </p:nvSpPr>
            <p:spPr>
              <a:xfrm>
                <a:off x="-6419770" y="-2202660"/>
                <a:ext cx="710143" cy="4673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A</a:t>
                </a:r>
                <a:endParaRPr lang="zh-CN" alt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2DBD5FA6-2191-75A9-09AC-64A57E7F44F5}"/>
                  </a:ext>
                </a:extLst>
              </p:cNvPr>
              <p:cNvSpPr txBox="1"/>
              <p:nvPr/>
            </p:nvSpPr>
            <p:spPr>
              <a:xfrm>
                <a:off x="-6440801" y="-129002"/>
                <a:ext cx="731174" cy="4673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V</a:t>
                </a:r>
                <a:endParaRPr lang="zh-CN" alt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DCE97324-0E59-4EC5-23B5-BE85127AF211}"/>
                  </a:ext>
                </a:extLst>
              </p:cNvPr>
              <p:cNvSpPr txBox="1"/>
              <p:nvPr/>
            </p:nvSpPr>
            <p:spPr>
              <a:xfrm>
                <a:off x="-5351108" y="-2478915"/>
                <a:ext cx="881356" cy="4673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A</a:t>
                </a:r>
                <a:endParaRPr lang="zh-CN" alt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12E4AD27-E358-9555-54EC-0143FB92536D}"/>
                  </a:ext>
                </a:extLst>
              </p:cNvPr>
              <p:cNvSpPr txBox="1"/>
              <p:nvPr/>
            </p:nvSpPr>
            <p:spPr>
              <a:xfrm>
                <a:off x="-4385910" y="-1488316"/>
                <a:ext cx="897682" cy="4673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V</a:t>
                </a:r>
                <a:endParaRPr lang="zh-CN" alt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8" name="组合 27">
                <a:extLst>
                  <a:ext uri="{FF2B5EF4-FFF2-40B4-BE49-F238E27FC236}">
                    <a16:creationId xmlns:a16="http://schemas.microsoft.com/office/drawing/2014/main" id="{0AE345B2-7F05-928E-6334-A8BFB44B4432}"/>
                  </a:ext>
                </a:extLst>
              </p:cNvPr>
              <p:cNvGrpSpPr/>
              <p:nvPr/>
            </p:nvGrpSpPr>
            <p:grpSpPr>
              <a:xfrm>
                <a:off x="-6995084" y="-498334"/>
                <a:ext cx="4494179" cy="1365945"/>
                <a:chOff x="-5354882" y="1575138"/>
                <a:chExt cx="4494179" cy="1365945"/>
              </a:xfrm>
            </p:grpSpPr>
            <p:sp>
              <p:nvSpPr>
                <p:cNvPr id="29" name="文本框 28">
                  <a:extLst>
                    <a:ext uri="{FF2B5EF4-FFF2-40B4-BE49-F238E27FC236}">
                      <a16:creationId xmlns:a16="http://schemas.microsoft.com/office/drawing/2014/main" id="{592F0AEE-FF96-064B-C04C-00581D74367E}"/>
                    </a:ext>
                  </a:extLst>
                </p:cNvPr>
                <p:cNvSpPr txBox="1"/>
                <p:nvPr/>
              </p:nvSpPr>
              <p:spPr>
                <a:xfrm>
                  <a:off x="-5354882" y="2459172"/>
                  <a:ext cx="4494179" cy="481911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1000" b="1" dirty="0">
                      <a:solidFill>
                        <a:schemeClr val="bg1"/>
                      </a:solidFill>
                    </a:rPr>
                    <a:t>The septal leaflet was enlarged</a:t>
                  </a:r>
                  <a:r>
                    <a:rPr lang="en-US" altLang="zh-CN" sz="105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.</a:t>
                  </a:r>
                  <a:endParaRPr lang="zh-CN" altLang="en-US" sz="105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0" name="直接箭头连接符 29">
                  <a:extLst>
                    <a:ext uri="{FF2B5EF4-FFF2-40B4-BE49-F238E27FC236}">
                      <a16:creationId xmlns:a16="http://schemas.microsoft.com/office/drawing/2014/main" id="{F46E2618-793E-3E26-4642-AEE47BF03A1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 flipV="1">
                  <a:off x="-4087131" y="1575138"/>
                  <a:ext cx="191204" cy="919744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2" name="组合 31">
                <a:extLst>
                  <a:ext uri="{FF2B5EF4-FFF2-40B4-BE49-F238E27FC236}">
                    <a16:creationId xmlns:a16="http://schemas.microsoft.com/office/drawing/2014/main" id="{6B17379D-F4C8-7C0E-BB4E-1D0E22F2CC20}"/>
                  </a:ext>
                </a:extLst>
              </p:cNvPr>
              <p:cNvGrpSpPr/>
              <p:nvPr/>
            </p:nvGrpSpPr>
            <p:grpSpPr>
              <a:xfrm>
                <a:off x="-9191840" y="-1693937"/>
                <a:ext cx="3354154" cy="438100"/>
                <a:chOff x="-291584" y="947593"/>
                <a:chExt cx="3354154" cy="438100"/>
              </a:xfrm>
            </p:grpSpPr>
            <p:sp>
              <p:nvSpPr>
                <p:cNvPr id="33" name="文本框 32">
                  <a:extLst>
                    <a:ext uri="{FF2B5EF4-FFF2-40B4-BE49-F238E27FC236}">
                      <a16:creationId xmlns:a16="http://schemas.microsoft.com/office/drawing/2014/main" id="{A3D19215-0054-F128-AEE9-FABC93632597}"/>
                    </a:ext>
                  </a:extLst>
                </p:cNvPr>
                <p:cNvSpPr txBox="1"/>
                <p:nvPr/>
              </p:nvSpPr>
              <p:spPr>
                <a:xfrm>
                  <a:off x="-291584" y="947593"/>
                  <a:ext cx="2456472" cy="438100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pPr algn="r"/>
                  <a:r>
                    <a:rPr lang="en-US" altLang="zh-CN" sz="9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epaired ASD</a:t>
                  </a:r>
                  <a:endParaRPr lang="zh-CN" altLang="en-US" sz="9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4" name="直接箭头连接符 33">
                  <a:extLst>
                    <a:ext uri="{FF2B5EF4-FFF2-40B4-BE49-F238E27FC236}">
                      <a16:creationId xmlns:a16="http://schemas.microsoft.com/office/drawing/2014/main" id="{FF73D5E6-FAEA-76A4-2980-718B7B1D093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164888" y="1153214"/>
                  <a:ext cx="897682" cy="88508"/>
                </a:xfrm>
                <a:prstGeom prst="straightConnector1">
                  <a:avLst/>
                </a:prstGeom>
                <a:ln w="28575">
                  <a:solidFill>
                    <a:schemeClr val="bg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8B8FE77D-82EE-42A8-45EB-4B77F097C560}"/>
                </a:ext>
              </a:extLst>
            </p:cNvPr>
            <p:cNvGrpSpPr/>
            <p:nvPr/>
          </p:nvGrpSpPr>
          <p:grpSpPr>
            <a:xfrm>
              <a:off x="10754261" y="-2612794"/>
              <a:ext cx="7468751" cy="5276387"/>
              <a:chOff x="-12538499" y="1891498"/>
              <a:chExt cx="7468751" cy="5276387"/>
            </a:xfrm>
          </p:grpSpPr>
          <p:pic>
            <p:nvPicPr>
              <p:cNvPr id="2" name="图片 1">
                <a:extLst>
                  <a:ext uri="{FF2B5EF4-FFF2-40B4-BE49-F238E27FC236}">
                    <a16:creationId xmlns:a16="http://schemas.microsoft.com/office/drawing/2014/main" id="{2627E687-2DFF-DE29-4A7F-049381806D8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rcRect l="2141" r="3045"/>
              <a:stretch>
                <a:fillRect/>
              </a:stretch>
            </p:blipFill>
            <p:spPr>
              <a:xfrm>
                <a:off x="-12538499" y="1891498"/>
                <a:ext cx="7468751" cy="5276387"/>
              </a:xfrm>
              <a:prstGeom prst="rect">
                <a:avLst/>
              </a:prstGeom>
            </p:spPr>
          </p:pic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C016ED8C-AFC0-A205-FEB7-8271D4C5DF1A}"/>
                  </a:ext>
                </a:extLst>
              </p:cNvPr>
              <p:cNvSpPr txBox="1"/>
              <p:nvPr/>
            </p:nvSpPr>
            <p:spPr>
              <a:xfrm>
                <a:off x="-12521310" y="1933941"/>
                <a:ext cx="642027" cy="49651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4114D597-2435-E73D-3B65-4679247E1B28}"/>
                  </a:ext>
                </a:extLst>
              </p:cNvPr>
              <p:cNvSpPr txBox="1"/>
              <p:nvPr/>
            </p:nvSpPr>
            <p:spPr>
              <a:xfrm>
                <a:off x="-8815387" y="3110985"/>
                <a:ext cx="683550" cy="4673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A</a:t>
                </a:r>
                <a:endParaRPr lang="zh-CN" alt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F9010851-1D34-7995-FA5B-1BDD57CC2492}"/>
                  </a:ext>
                </a:extLst>
              </p:cNvPr>
              <p:cNvSpPr txBox="1"/>
              <p:nvPr/>
            </p:nvSpPr>
            <p:spPr>
              <a:xfrm>
                <a:off x="-8734951" y="4916686"/>
                <a:ext cx="967896" cy="4673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V</a:t>
                </a:r>
                <a:endParaRPr lang="zh-CN" alt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7638CF08-049F-4B84-345E-51C29FA48C42}"/>
                  </a:ext>
                </a:extLst>
              </p:cNvPr>
              <p:cNvSpPr txBox="1"/>
              <p:nvPr/>
            </p:nvSpPr>
            <p:spPr>
              <a:xfrm>
                <a:off x="-11410011" y="5669083"/>
                <a:ext cx="5390386" cy="46730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b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dge-to-edge repair of mitral valve</a:t>
                </a:r>
                <a:endParaRPr lang="zh-CN" altLang="en-US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0" name="直接箭头连接符 39">
                <a:extLst>
                  <a:ext uri="{FF2B5EF4-FFF2-40B4-BE49-F238E27FC236}">
                    <a16:creationId xmlns:a16="http://schemas.microsoft.com/office/drawing/2014/main" id="{AFA68A98-D252-AB9A-879F-11464E9578A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-9572555" y="4522126"/>
                <a:ext cx="677012" cy="1111630"/>
              </a:xfrm>
              <a:prstGeom prst="straightConnector1">
                <a:avLst/>
              </a:prstGeom>
              <a:ln w="28575">
                <a:solidFill>
                  <a:schemeClr val="bg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4" name="组合 43">
              <a:extLst>
                <a:ext uri="{FF2B5EF4-FFF2-40B4-BE49-F238E27FC236}">
                  <a16:creationId xmlns:a16="http://schemas.microsoft.com/office/drawing/2014/main" id="{65633EE1-C178-B35D-FD0B-F953BB0D64A0}"/>
                </a:ext>
              </a:extLst>
            </p:cNvPr>
            <p:cNvGrpSpPr/>
            <p:nvPr/>
          </p:nvGrpSpPr>
          <p:grpSpPr>
            <a:xfrm>
              <a:off x="-4439360" y="2792904"/>
              <a:ext cx="7468751" cy="5276387"/>
              <a:chOff x="-4598644" y="2792904"/>
              <a:chExt cx="7468751" cy="5276387"/>
            </a:xfrm>
          </p:grpSpPr>
          <p:pic>
            <p:nvPicPr>
              <p:cNvPr id="19" name="图片 18">
                <a:extLst>
                  <a:ext uri="{FF2B5EF4-FFF2-40B4-BE49-F238E27FC236}">
                    <a16:creationId xmlns:a16="http://schemas.microsoft.com/office/drawing/2014/main" id="{FB26186F-286F-D2A0-2475-A8D92099E49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748" t="10381" r="242" b="3892"/>
              <a:stretch>
                <a:fillRect/>
              </a:stretch>
            </p:blipFill>
            <p:spPr>
              <a:xfrm>
                <a:off x="-4598644" y="2792904"/>
                <a:ext cx="7468751" cy="5276387"/>
              </a:xfrm>
              <a:prstGeom prst="rect">
                <a:avLst/>
              </a:prstGeom>
            </p:spPr>
          </p:pic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71586544-F4C6-45B6-ABF1-5D93BF61876E}"/>
                  </a:ext>
                </a:extLst>
              </p:cNvPr>
              <p:cNvSpPr txBox="1"/>
              <p:nvPr/>
            </p:nvSpPr>
            <p:spPr>
              <a:xfrm>
                <a:off x="-4547628" y="2802692"/>
                <a:ext cx="642027" cy="49651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685362A5-34ED-5640-EB65-0EABA0C61D48}"/>
                </a:ext>
              </a:extLst>
            </p:cNvPr>
            <p:cNvSpPr txBox="1"/>
            <p:nvPr/>
          </p:nvSpPr>
          <p:spPr>
            <a:xfrm>
              <a:off x="-2301790" y="6978725"/>
              <a:ext cx="5390388" cy="46730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uble orifice of mitral valve</a:t>
              </a:r>
              <a:endParaRPr lang="zh-CN" altLang="en-US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" name="直接箭头连接符 42">
              <a:extLst>
                <a:ext uri="{FF2B5EF4-FFF2-40B4-BE49-F238E27FC236}">
                  <a16:creationId xmlns:a16="http://schemas.microsoft.com/office/drawing/2014/main" id="{3DC8E740-E018-379E-393B-9CF7C9B2349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-1150373" y="5481897"/>
              <a:ext cx="544881" cy="1496829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箭头连接符 45">
              <a:extLst>
                <a:ext uri="{FF2B5EF4-FFF2-40B4-BE49-F238E27FC236}">
                  <a16:creationId xmlns:a16="http://schemas.microsoft.com/office/drawing/2014/main" id="{E1E0FD2A-6DFD-EB92-57FB-812C42EF4AB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-605492" y="5615959"/>
              <a:ext cx="411197" cy="1350521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FC82D529-EF9B-C5E1-FF66-05443206F840}"/>
                </a:ext>
              </a:extLst>
            </p:cNvPr>
            <p:cNvGrpSpPr/>
            <p:nvPr/>
          </p:nvGrpSpPr>
          <p:grpSpPr>
            <a:xfrm>
              <a:off x="10754261" y="2785338"/>
              <a:ext cx="7468751" cy="5276388"/>
              <a:chOff x="10265861" y="1883932"/>
              <a:chExt cx="7468751" cy="5276388"/>
            </a:xfrm>
          </p:grpSpPr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BB8A0C2E-BC32-BD2B-D56F-ED3F09D3AD8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183" t="11492" r="1029" b="3934"/>
              <a:stretch>
                <a:fillRect/>
              </a:stretch>
            </p:blipFill>
            <p:spPr>
              <a:xfrm>
                <a:off x="10265861" y="1883932"/>
                <a:ext cx="7468751" cy="5276388"/>
              </a:xfrm>
              <a:prstGeom prst="rect">
                <a:avLst/>
              </a:prstGeom>
            </p:spPr>
          </p:pic>
          <p:sp>
            <p:nvSpPr>
              <p:cNvPr id="35" name="文本框 34">
                <a:extLst>
                  <a:ext uri="{FF2B5EF4-FFF2-40B4-BE49-F238E27FC236}">
                    <a16:creationId xmlns:a16="http://schemas.microsoft.com/office/drawing/2014/main" id="{1EB6B4A6-F13D-15D6-60F5-C02EB4E49239}"/>
                  </a:ext>
                </a:extLst>
              </p:cNvPr>
              <p:cNvSpPr txBox="1"/>
              <p:nvPr/>
            </p:nvSpPr>
            <p:spPr>
              <a:xfrm>
                <a:off x="10285745" y="1921241"/>
                <a:ext cx="642027" cy="49651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endParaRPr lang="zh-CN" altLang="en-US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87466784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17</TotalTime>
  <Words>35</Words>
  <Application>Microsoft Office PowerPoint</Application>
  <PresentationFormat>宽屏</PresentationFormat>
  <Paragraphs>19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4" baseType="lpstr">
      <vt:lpstr>等线</vt:lpstr>
      <vt:lpstr>Arial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uajie zheng</dc:creator>
  <cp:lastModifiedBy>huajie zheng</cp:lastModifiedBy>
  <cp:revision>282</cp:revision>
  <dcterms:created xsi:type="dcterms:W3CDTF">2023-08-09T12:44:55Z</dcterms:created>
  <dcterms:modified xsi:type="dcterms:W3CDTF">2026-01-20T07:12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259</vt:lpwstr>
  </property>
</Properties>
</file>